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4"/>
  </p:sldMasterIdLst>
  <p:notesMasterIdLst>
    <p:notesMasterId r:id="rId6"/>
  </p:notesMasterIdLst>
  <p:sldIdLst>
    <p:sldId id="257" r:id="rId5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Frits Berends" initials="FB" lastIdx="1" clrIdx="0">
    <p:extLst>
      <p:ext uri="{19B8F6BF-5375-455C-9EA6-DF929625EA0E}">
        <p15:presenceInfo xmlns:p15="http://schemas.microsoft.com/office/powerpoint/2012/main" userId="988ce62ec93472c6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0F0F0"/>
    <a:srgbClr val="AED6F9"/>
    <a:srgbClr val="8C97EC"/>
    <a:srgbClr val="99B2DF"/>
    <a:srgbClr val="E49991"/>
    <a:srgbClr val="FFC9C2"/>
    <a:srgbClr val="7B0101"/>
    <a:srgbClr val="950101"/>
    <a:srgbClr val="FFA9A0"/>
    <a:srgbClr val="6F7AB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91D5302F-E9E6-4EA3-8EAE-00262C85783C}" v="215" dt="2026-01-09T14:15:42.054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763"/>
    <p:restoredTop sz="92947"/>
  </p:normalViewPr>
  <p:slideViewPr>
    <p:cSldViewPr snapToGrid="0">
      <p:cViewPr varScale="1">
        <p:scale>
          <a:sx n="87" d="100"/>
          <a:sy n="87" d="100"/>
        </p:scale>
        <p:origin x="510" y="9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13" Type="http://schemas.microsoft.com/office/2015/10/relationships/revisionInfo" Target="revisionInfo.xml"/><Relationship Id="rId3" Type="http://schemas.openxmlformats.org/officeDocument/2006/relationships/customXml" Target="../customXml/item3.xml"/><Relationship Id="rId7" Type="http://schemas.openxmlformats.org/officeDocument/2006/relationships/commentAuthors" Target="commentAuthors.xml"/><Relationship Id="rId12" Type="http://schemas.microsoft.com/office/2016/11/relationships/changesInfo" Target="changesInfos/changesInfo1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11" Type="http://schemas.openxmlformats.org/officeDocument/2006/relationships/tableStyles" Target="tableStyles.xml"/><Relationship Id="rId5" Type="http://schemas.openxmlformats.org/officeDocument/2006/relationships/slide" Target="slides/slide1.xml"/><Relationship Id="rId10" Type="http://schemas.openxmlformats.org/officeDocument/2006/relationships/theme" Target="theme/theme1.xml"/><Relationship Id="rId4" Type="http://schemas.openxmlformats.org/officeDocument/2006/relationships/slideMaster" Target="slideMasters/slideMaster1.xml"/><Relationship Id="rId9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Harker, Mitchell" userId="24877696-3057-46bf-8cc5-2e9f99c74af1" providerId="ADAL" clId="{91D5302F-E9E6-4EA3-8EAE-00262C85783C}"/>
    <pc:docChg chg="undo custSel modSld">
      <pc:chgData name="Harker, Mitchell" userId="24877696-3057-46bf-8cc5-2e9f99c74af1" providerId="ADAL" clId="{91D5302F-E9E6-4EA3-8EAE-00262C85783C}" dt="2026-01-09T14:17:11.292" v="737" actId="1035"/>
      <pc:docMkLst>
        <pc:docMk/>
      </pc:docMkLst>
      <pc:sldChg chg="addSp delSp modSp mod delAnim modAnim">
        <pc:chgData name="Harker, Mitchell" userId="24877696-3057-46bf-8cc5-2e9f99c74af1" providerId="ADAL" clId="{91D5302F-E9E6-4EA3-8EAE-00262C85783C}" dt="2026-01-09T14:17:11.292" v="737" actId="1035"/>
        <pc:sldMkLst>
          <pc:docMk/>
          <pc:sldMk cId="1219068927" sldId="257"/>
        </pc:sldMkLst>
        <pc:spChg chg="mod">
          <ac:chgData name="Harker, Mitchell" userId="24877696-3057-46bf-8cc5-2e9f99c74af1" providerId="ADAL" clId="{91D5302F-E9E6-4EA3-8EAE-00262C85783C}" dt="2026-01-09T14:13:45.174" v="654" actId="1035"/>
          <ac:spMkLst>
            <pc:docMk/>
            <pc:sldMk cId="1219068927" sldId="257"/>
            <ac:spMk id="4" creationId="{5C047ED4-52E3-4A2A-948B-20CE7D7233A4}"/>
          </ac:spMkLst>
        </pc:spChg>
        <pc:spChg chg="mod">
          <ac:chgData name="Harker, Mitchell" userId="24877696-3057-46bf-8cc5-2e9f99c74af1" providerId="ADAL" clId="{91D5302F-E9E6-4EA3-8EAE-00262C85783C}" dt="2026-01-09T13:30:29.616" v="78" actId="1076"/>
          <ac:spMkLst>
            <pc:docMk/>
            <pc:sldMk cId="1219068927" sldId="257"/>
            <ac:spMk id="5" creationId="{57C6657B-C862-4624-AF23-0815F276EF35}"/>
          </ac:spMkLst>
        </pc:spChg>
        <pc:spChg chg="add del">
          <ac:chgData name="Harker, Mitchell" userId="24877696-3057-46bf-8cc5-2e9f99c74af1" providerId="ADAL" clId="{91D5302F-E9E6-4EA3-8EAE-00262C85783C}" dt="2026-01-09T13:12:39.597" v="48" actId="478"/>
          <ac:spMkLst>
            <pc:docMk/>
            <pc:sldMk cId="1219068927" sldId="257"/>
            <ac:spMk id="9" creationId="{F023C448-C105-42E2-2B4B-C9357D13F95B}"/>
          </ac:spMkLst>
        </pc:spChg>
        <pc:spChg chg="mod">
          <ac:chgData name="Harker, Mitchell" userId="24877696-3057-46bf-8cc5-2e9f99c74af1" providerId="ADAL" clId="{91D5302F-E9E6-4EA3-8EAE-00262C85783C}" dt="2026-01-09T14:12:05.342" v="629" actId="20577"/>
          <ac:spMkLst>
            <pc:docMk/>
            <pc:sldMk cId="1219068927" sldId="257"/>
            <ac:spMk id="11" creationId="{7E841DD3-FD98-4EB0-9BD3-D2A17CABA7C9}"/>
          </ac:spMkLst>
        </pc:spChg>
        <pc:spChg chg="add mod">
          <ac:chgData name="Harker, Mitchell" userId="24877696-3057-46bf-8cc5-2e9f99c74af1" providerId="ADAL" clId="{91D5302F-E9E6-4EA3-8EAE-00262C85783C}" dt="2026-01-09T13:30:39.715" v="79" actId="164"/>
          <ac:spMkLst>
            <pc:docMk/>
            <pc:sldMk cId="1219068927" sldId="257"/>
            <ac:spMk id="19" creationId="{A36B0FFA-6066-3932-6584-2A8403E22D26}"/>
          </ac:spMkLst>
        </pc:spChg>
        <pc:spChg chg="add mod">
          <ac:chgData name="Harker, Mitchell" userId="24877696-3057-46bf-8cc5-2e9f99c74af1" providerId="ADAL" clId="{91D5302F-E9E6-4EA3-8EAE-00262C85783C}" dt="2026-01-09T13:30:39.715" v="79" actId="164"/>
          <ac:spMkLst>
            <pc:docMk/>
            <pc:sldMk cId="1219068927" sldId="257"/>
            <ac:spMk id="20" creationId="{6466D782-DFCC-8964-CFF0-44DB427348B7}"/>
          </ac:spMkLst>
        </pc:spChg>
        <pc:spChg chg="add mod">
          <ac:chgData name="Harker, Mitchell" userId="24877696-3057-46bf-8cc5-2e9f99c74af1" providerId="ADAL" clId="{91D5302F-E9E6-4EA3-8EAE-00262C85783C}" dt="2026-01-09T13:49:14.008" v="270" actId="1036"/>
          <ac:spMkLst>
            <pc:docMk/>
            <pc:sldMk cId="1219068927" sldId="257"/>
            <ac:spMk id="24" creationId="{E3B61A29-FE84-1C98-59F6-CEDFBBDC164E}"/>
          </ac:spMkLst>
        </pc:spChg>
        <pc:spChg chg="add mod">
          <ac:chgData name="Harker, Mitchell" userId="24877696-3057-46bf-8cc5-2e9f99c74af1" providerId="ADAL" clId="{91D5302F-E9E6-4EA3-8EAE-00262C85783C}" dt="2026-01-09T13:49:14.008" v="270" actId="1036"/>
          <ac:spMkLst>
            <pc:docMk/>
            <pc:sldMk cId="1219068927" sldId="257"/>
            <ac:spMk id="25" creationId="{D1B2D1EC-EF45-5460-5C5A-11127F41EF19}"/>
          </ac:spMkLst>
        </pc:spChg>
        <pc:spChg chg="add mod">
          <ac:chgData name="Harker, Mitchell" userId="24877696-3057-46bf-8cc5-2e9f99c74af1" providerId="ADAL" clId="{91D5302F-E9E6-4EA3-8EAE-00262C85783C}" dt="2026-01-09T13:49:14.008" v="270" actId="1036"/>
          <ac:spMkLst>
            <pc:docMk/>
            <pc:sldMk cId="1219068927" sldId="257"/>
            <ac:spMk id="26" creationId="{BB5469D2-C52B-98B3-2B4C-FBB86B197C0D}"/>
          </ac:spMkLst>
        </pc:spChg>
        <pc:spChg chg="add mod">
          <ac:chgData name="Harker, Mitchell" userId="24877696-3057-46bf-8cc5-2e9f99c74af1" providerId="ADAL" clId="{91D5302F-E9E6-4EA3-8EAE-00262C85783C}" dt="2026-01-09T13:49:14.008" v="270" actId="1036"/>
          <ac:spMkLst>
            <pc:docMk/>
            <pc:sldMk cId="1219068927" sldId="257"/>
            <ac:spMk id="27" creationId="{0F44C84C-2A81-6570-4A59-0766BE5156B9}"/>
          </ac:spMkLst>
        </pc:spChg>
        <pc:spChg chg="add mod">
          <ac:chgData name="Harker, Mitchell" userId="24877696-3057-46bf-8cc5-2e9f99c74af1" providerId="ADAL" clId="{91D5302F-E9E6-4EA3-8EAE-00262C85783C}" dt="2026-01-09T13:50:04.321" v="284" actId="1035"/>
          <ac:spMkLst>
            <pc:docMk/>
            <pc:sldMk cId="1219068927" sldId="257"/>
            <ac:spMk id="28" creationId="{7133CA99-0010-BEDB-72F7-BEE2FF898C2A}"/>
          </ac:spMkLst>
        </pc:spChg>
        <pc:spChg chg="add mod">
          <ac:chgData name="Harker, Mitchell" userId="24877696-3057-46bf-8cc5-2e9f99c74af1" providerId="ADAL" clId="{91D5302F-E9E6-4EA3-8EAE-00262C85783C}" dt="2026-01-09T13:49:44.024" v="279" actId="1035"/>
          <ac:spMkLst>
            <pc:docMk/>
            <pc:sldMk cId="1219068927" sldId="257"/>
            <ac:spMk id="29" creationId="{704A9419-7C24-62ED-881C-79C46C5E8190}"/>
          </ac:spMkLst>
        </pc:spChg>
        <pc:spChg chg="add mod">
          <ac:chgData name="Harker, Mitchell" userId="24877696-3057-46bf-8cc5-2e9f99c74af1" providerId="ADAL" clId="{91D5302F-E9E6-4EA3-8EAE-00262C85783C}" dt="2026-01-09T13:57:35.030" v="343" actId="20577"/>
          <ac:spMkLst>
            <pc:docMk/>
            <pc:sldMk cId="1219068927" sldId="257"/>
            <ac:spMk id="30" creationId="{1CB6E54D-5C62-4266-C3B7-FED6878E76A7}"/>
          </ac:spMkLst>
        </pc:spChg>
        <pc:spChg chg="add mod">
          <ac:chgData name="Harker, Mitchell" userId="24877696-3057-46bf-8cc5-2e9f99c74af1" providerId="ADAL" clId="{91D5302F-E9E6-4EA3-8EAE-00262C85783C}" dt="2026-01-09T14:01:03.508" v="354" actId="1076"/>
          <ac:spMkLst>
            <pc:docMk/>
            <pc:sldMk cId="1219068927" sldId="257"/>
            <ac:spMk id="32" creationId="{D2CEB771-5125-69A0-6453-E2334BFF5D1F}"/>
          </ac:spMkLst>
        </pc:spChg>
        <pc:spChg chg="add mod">
          <ac:chgData name="Harker, Mitchell" userId="24877696-3057-46bf-8cc5-2e9f99c74af1" providerId="ADAL" clId="{91D5302F-E9E6-4EA3-8EAE-00262C85783C}" dt="2026-01-09T14:05:31.657" v="458" actId="208"/>
          <ac:spMkLst>
            <pc:docMk/>
            <pc:sldMk cId="1219068927" sldId="257"/>
            <ac:spMk id="33" creationId="{7240DAAE-BB03-C24F-7FA4-BBB2A9A26EE8}"/>
          </ac:spMkLst>
        </pc:spChg>
        <pc:spChg chg="add mod">
          <ac:chgData name="Harker, Mitchell" userId="24877696-3057-46bf-8cc5-2e9f99c74af1" providerId="ADAL" clId="{91D5302F-E9E6-4EA3-8EAE-00262C85783C}" dt="2026-01-09T14:01:29.262" v="357" actId="1076"/>
          <ac:spMkLst>
            <pc:docMk/>
            <pc:sldMk cId="1219068927" sldId="257"/>
            <ac:spMk id="34" creationId="{D3984141-7FB9-BD38-A6B8-B83AEE9F95B7}"/>
          </ac:spMkLst>
        </pc:spChg>
        <pc:spChg chg="add mod">
          <ac:chgData name="Harker, Mitchell" userId="24877696-3057-46bf-8cc5-2e9f99c74af1" providerId="ADAL" clId="{91D5302F-E9E6-4EA3-8EAE-00262C85783C}" dt="2026-01-09T14:01:14.090" v="355" actId="1076"/>
          <ac:spMkLst>
            <pc:docMk/>
            <pc:sldMk cId="1219068927" sldId="257"/>
            <ac:spMk id="35" creationId="{BD551973-20FE-AB39-5B53-1991DB90A4F5}"/>
          </ac:spMkLst>
        </pc:spChg>
        <pc:spChg chg="add mod">
          <ac:chgData name="Harker, Mitchell" userId="24877696-3057-46bf-8cc5-2e9f99c74af1" providerId="ADAL" clId="{91D5302F-E9E6-4EA3-8EAE-00262C85783C}" dt="2026-01-09T14:01:52.506" v="359" actId="1076"/>
          <ac:spMkLst>
            <pc:docMk/>
            <pc:sldMk cId="1219068927" sldId="257"/>
            <ac:spMk id="36" creationId="{348C7529-2995-53B1-D538-033AD1790640}"/>
          </ac:spMkLst>
        </pc:spChg>
        <pc:spChg chg="add mod">
          <ac:chgData name="Harker, Mitchell" userId="24877696-3057-46bf-8cc5-2e9f99c74af1" providerId="ADAL" clId="{91D5302F-E9E6-4EA3-8EAE-00262C85783C}" dt="2026-01-09T14:08:55.671" v="618" actId="1076"/>
          <ac:spMkLst>
            <pc:docMk/>
            <pc:sldMk cId="1219068927" sldId="257"/>
            <ac:spMk id="37" creationId="{C9E1EA57-6D8A-1D64-77E9-A126FD5D8F93}"/>
          </ac:spMkLst>
        </pc:spChg>
        <pc:spChg chg="add del mod">
          <ac:chgData name="Harker, Mitchell" userId="24877696-3057-46bf-8cc5-2e9f99c74af1" providerId="ADAL" clId="{91D5302F-E9E6-4EA3-8EAE-00262C85783C}" dt="2026-01-09T14:03:46.631" v="432" actId="478"/>
          <ac:spMkLst>
            <pc:docMk/>
            <pc:sldMk cId="1219068927" sldId="257"/>
            <ac:spMk id="38" creationId="{E9F3D6B8-044B-3521-5CC4-522D0B48618E}"/>
          </ac:spMkLst>
        </pc:spChg>
        <pc:spChg chg="add mod">
          <ac:chgData name="Harker, Mitchell" userId="24877696-3057-46bf-8cc5-2e9f99c74af1" providerId="ADAL" clId="{91D5302F-E9E6-4EA3-8EAE-00262C85783C}" dt="2026-01-09T14:08:55.671" v="618" actId="1076"/>
          <ac:spMkLst>
            <pc:docMk/>
            <pc:sldMk cId="1219068927" sldId="257"/>
            <ac:spMk id="39" creationId="{FE5E2807-64B4-8D7B-90D9-0214159A81E5}"/>
          </ac:spMkLst>
        </pc:spChg>
        <pc:spChg chg="add del mod">
          <ac:chgData name="Harker, Mitchell" userId="24877696-3057-46bf-8cc5-2e9f99c74af1" providerId="ADAL" clId="{91D5302F-E9E6-4EA3-8EAE-00262C85783C}" dt="2026-01-09T14:07:40.971" v="527" actId="478"/>
          <ac:spMkLst>
            <pc:docMk/>
            <pc:sldMk cId="1219068927" sldId="257"/>
            <ac:spMk id="40" creationId="{7E9697AB-494F-B66C-4754-5A4326FC7EE7}"/>
          </ac:spMkLst>
        </pc:spChg>
        <pc:spChg chg="add del mod">
          <ac:chgData name="Harker, Mitchell" userId="24877696-3057-46bf-8cc5-2e9f99c74af1" providerId="ADAL" clId="{91D5302F-E9E6-4EA3-8EAE-00262C85783C}" dt="2026-01-09T14:07:40.971" v="527" actId="478"/>
          <ac:spMkLst>
            <pc:docMk/>
            <pc:sldMk cId="1219068927" sldId="257"/>
            <ac:spMk id="41" creationId="{B50F9621-A76E-2FE1-54B9-46D48996EBF8}"/>
          </ac:spMkLst>
        </pc:spChg>
        <pc:spChg chg="add mod">
          <ac:chgData name="Harker, Mitchell" userId="24877696-3057-46bf-8cc5-2e9f99c74af1" providerId="ADAL" clId="{91D5302F-E9E6-4EA3-8EAE-00262C85783C}" dt="2026-01-09T14:08:55.671" v="618" actId="1076"/>
          <ac:spMkLst>
            <pc:docMk/>
            <pc:sldMk cId="1219068927" sldId="257"/>
            <ac:spMk id="42" creationId="{25472ADC-4759-7048-FE14-5431AEB3E2BC}"/>
          </ac:spMkLst>
        </pc:spChg>
        <pc:spChg chg="add mod">
          <ac:chgData name="Harker, Mitchell" userId="24877696-3057-46bf-8cc5-2e9f99c74af1" providerId="ADAL" clId="{91D5302F-E9E6-4EA3-8EAE-00262C85783C}" dt="2026-01-09T14:08:55.671" v="618" actId="1076"/>
          <ac:spMkLst>
            <pc:docMk/>
            <pc:sldMk cId="1219068927" sldId="257"/>
            <ac:spMk id="43" creationId="{2394371F-8A33-89BB-983F-46571C1C1992}"/>
          </ac:spMkLst>
        </pc:spChg>
        <pc:spChg chg="add mod">
          <ac:chgData name="Harker, Mitchell" userId="24877696-3057-46bf-8cc5-2e9f99c74af1" providerId="ADAL" clId="{91D5302F-E9E6-4EA3-8EAE-00262C85783C}" dt="2026-01-09T14:17:11.292" v="737" actId="1035"/>
          <ac:spMkLst>
            <pc:docMk/>
            <pc:sldMk cId="1219068927" sldId="257"/>
            <ac:spMk id="44" creationId="{61B74AB0-3A4D-F8C2-8CA6-789B7323E54F}"/>
          </ac:spMkLst>
        </pc:spChg>
        <pc:spChg chg="add mod">
          <ac:chgData name="Harker, Mitchell" userId="24877696-3057-46bf-8cc5-2e9f99c74af1" providerId="ADAL" clId="{91D5302F-E9E6-4EA3-8EAE-00262C85783C}" dt="2026-01-09T14:17:11.292" v="737" actId="1035"/>
          <ac:spMkLst>
            <pc:docMk/>
            <pc:sldMk cId="1219068927" sldId="257"/>
            <ac:spMk id="45" creationId="{491F5F53-1CBA-E2B7-3F25-4DFE8350AF0D}"/>
          </ac:spMkLst>
        </pc:spChg>
        <pc:spChg chg="add mod">
          <ac:chgData name="Harker, Mitchell" userId="24877696-3057-46bf-8cc5-2e9f99c74af1" providerId="ADAL" clId="{91D5302F-E9E6-4EA3-8EAE-00262C85783C}" dt="2026-01-09T14:17:11.292" v="737" actId="1035"/>
          <ac:spMkLst>
            <pc:docMk/>
            <pc:sldMk cId="1219068927" sldId="257"/>
            <ac:spMk id="46" creationId="{A2B591DB-E2D8-7C8D-AF13-2F7467B64E33}"/>
          </ac:spMkLst>
        </pc:spChg>
        <pc:spChg chg="add del mod">
          <ac:chgData name="Harker, Mitchell" userId="24877696-3057-46bf-8cc5-2e9f99c74af1" providerId="ADAL" clId="{91D5302F-E9E6-4EA3-8EAE-00262C85783C}" dt="2026-01-09T14:16:59.429" v="708" actId="478"/>
          <ac:spMkLst>
            <pc:docMk/>
            <pc:sldMk cId="1219068927" sldId="257"/>
            <ac:spMk id="47" creationId="{896599C1-DDFE-90E8-7C23-69A88F22E8BB}"/>
          </ac:spMkLst>
        </pc:spChg>
        <pc:spChg chg="add mod">
          <ac:chgData name="Harker, Mitchell" userId="24877696-3057-46bf-8cc5-2e9f99c74af1" providerId="ADAL" clId="{91D5302F-E9E6-4EA3-8EAE-00262C85783C}" dt="2026-01-09T14:17:11.292" v="737" actId="1035"/>
          <ac:spMkLst>
            <pc:docMk/>
            <pc:sldMk cId="1219068927" sldId="257"/>
            <ac:spMk id="48" creationId="{62534CFD-2526-7FB1-D2D1-7CABA8E4DA7C}"/>
          </ac:spMkLst>
        </pc:spChg>
        <pc:spChg chg="add mod">
          <ac:chgData name="Harker, Mitchell" userId="24877696-3057-46bf-8cc5-2e9f99c74af1" providerId="ADAL" clId="{91D5302F-E9E6-4EA3-8EAE-00262C85783C}" dt="2026-01-09T14:17:11.292" v="737" actId="1035"/>
          <ac:spMkLst>
            <pc:docMk/>
            <pc:sldMk cId="1219068927" sldId="257"/>
            <ac:spMk id="49" creationId="{5D845F31-7F20-A733-E64C-4300D51C089D}"/>
          </ac:spMkLst>
        </pc:spChg>
        <pc:grpChg chg="add del mod">
          <ac:chgData name="Harker, Mitchell" userId="24877696-3057-46bf-8cc5-2e9f99c74af1" providerId="ADAL" clId="{91D5302F-E9E6-4EA3-8EAE-00262C85783C}" dt="2026-01-09T13:44:17.876" v="86" actId="478"/>
          <ac:grpSpMkLst>
            <pc:docMk/>
            <pc:sldMk cId="1219068927" sldId="257"/>
            <ac:grpSpMk id="21" creationId="{EB955D58-9056-A2E4-F6DE-6232DD5689EB}"/>
          </ac:grpSpMkLst>
        </pc:grpChg>
        <pc:picChg chg="add del mod">
          <ac:chgData name="Harker, Mitchell" userId="24877696-3057-46bf-8cc5-2e9f99c74af1" providerId="ADAL" clId="{91D5302F-E9E6-4EA3-8EAE-00262C85783C}" dt="2026-01-09T13:27:05.738" v="53" actId="478"/>
          <ac:picMkLst>
            <pc:docMk/>
            <pc:sldMk cId="1219068927" sldId="257"/>
            <ac:picMk id="10" creationId="{9543C781-F940-DB5A-6DF8-C2E351781D15}"/>
          </ac:picMkLst>
        </pc:picChg>
        <pc:picChg chg="add del mod">
          <ac:chgData name="Harker, Mitchell" userId="24877696-3057-46bf-8cc5-2e9f99c74af1" providerId="ADAL" clId="{91D5302F-E9E6-4EA3-8EAE-00262C85783C}" dt="2026-01-09T13:28:00.571" v="56" actId="478"/>
          <ac:picMkLst>
            <pc:docMk/>
            <pc:sldMk cId="1219068927" sldId="257"/>
            <ac:picMk id="12" creationId="{D9E9DB29-6B2A-3B66-1928-E7198EF6587C}"/>
          </ac:picMkLst>
        </pc:picChg>
        <pc:picChg chg="add mod">
          <ac:chgData name="Harker, Mitchell" userId="24877696-3057-46bf-8cc5-2e9f99c74af1" providerId="ADAL" clId="{91D5302F-E9E6-4EA3-8EAE-00262C85783C}" dt="2026-01-09T13:31:29.106" v="84"/>
          <ac:picMkLst>
            <pc:docMk/>
            <pc:sldMk cId="1219068927" sldId="257"/>
            <ac:picMk id="15" creationId="{32509E1C-15B2-368B-562E-D5FFE0174CAC}"/>
          </ac:picMkLst>
        </pc:picChg>
        <pc:picChg chg="add mod">
          <ac:chgData name="Harker, Mitchell" userId="24877696-3057-46bf-8cc5-2e9f99c74af1" providerId="ADAL" clId="{91D5302F-E9E6-4EA3-8EAE-00262C85783C}" dt="2026-01-09T13:31:47.640" v="85"/>
          <ac:picMkLst>
            <pc:docMk/>
            <pc:sldMk cId="1219068927" sldId="257"/>
            <ac:picMk id="17" creationId="{5513C7F0-85E5-F02E-54A0-47057DACE1F4}"/>
          </ac:picMkLst>
        </pc:picChg>
        <pc:picChg chg="add mod">
          <ac:chgData name="Harker, Mitchell" userId="24877696-3057-46bf-8cc5-2e9f99c74af1" providerId="ADAL" clId="{91D5302F-E9E6-4EA3-8EAE-00262C85783C}" dt="2026-01-09T13:49:14.008" v="270" actId="1036"/>
          <ac:picMkLst>
            <pc:docMk/>
            <pc:sldMk cId="1219068927" sldId="257"/>
            <ac:picMk id="23" creationId="{B070DF84-7CB3-635F-D661-83C8E9A22F87}"/>
          </ac:picMkLst>
        </pc:picChg>
        <pc:picChg chg="add mod">
          <ac:chgData name="Harker, Mitchell" userId="24877696-3057-46bf-8cc5-2e9f99c74af1" providerId="ADAL" clId="{91D5302F-E9E6-4EA3-8EAE-00262C85783C}" dt="2026-01-09T14:08:34.487" v="602" actId="1076"/>
          <ac:picMkLst>
            <pc:docMk/>
            <pc:sldMk cId="1219068927" sldId="257"/>
            <ac:picMk id="31" creationId="{82D351CE-3A2D-9710-548A-AEF418897828}"/>
          </ac:picMkLst>
        </pc:picChg>
      </pc:sldChg>
    </pc:docChg>
  </pc:docChgLst>
  <pc:docChgLst>
    <pc:chgData name="Deana Rodriguez" userId="a6c3ea7d12529229" providerId="LiveId" clId="{6C998536-C737-469F-9383-CEB138CB3D9D}"/>
    <pc:docChg chg="undo custSel modSld">
      <pc:chgData name="Deana Rodriguez" userId="a6c3ea7d12529229" providerId="LiveId" clId="{6C998536-C737-469F-9383-CEB138CB3D9D}" dt="2021-04-12T20:48:54.789" v="111" actId="122"/>
      <pc:docMkLst>
        <pc:docMk/>
      </pc:docMkLst>
      <pc:sldChg chg="addSp delSp modSp mod">
        <pc:chgData name="Deana Rodriguez" userId="a6c3ea7d12529229" providerId="LiveId" clId="{6C998536-C737-469F-9383-CEB138CB3D9D}" dt="2021-04-12T20:48:54.789" v="111" actId="122"/>
        <pc:sldMkLst>
          <pc:docMk/>
          <pc:sldMk cId="1219068927" sldId="257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44C72DB-605E-0F4B-BEFA-F419CD777762}" type="datetimeFigureOut">
              <a:rPr lang="en-US" smtClean="0"/>
              <a:t>1/9/202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2032445-0623-A84C-A2C0-69350AC3936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740999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ctr"/>
            <a:r>
              <a:rPr lang="en-US" dirty="0"/>
              <a:t>LU Biter, MMA Van </a:t>
            </a:r>
            <a:r>
              <a:rPr lang="en-US" dirty="0" err="1"/>
              <a:t>Buuren</a:t>
            </a:r>
            <a:r>
              <a:rPr lang="en-US" dirty="0"/>
              <a:t>, GHH </a:t>
            </a:r>
            <a:r>
              <a:rPr lang="en-US" dirty="0" err="1"/>
              <a:t>Mannaerts</a:t>
            </a:r>
            <a:endParaRPr lang="en-US" dirty="0"/>
          </a:p>
          <a:p>
            <a:pPr algn="ctr"/>
            <a:r>
              <a:rPr lang="en-US" dirty="0"/>
              <a:t>JA </a:t>
            </a:r>
            <a:r>
              <a:rPr lang="en-US" dirty="0" err="1"/>
              <a:t>Apers</a:t>
            </a:r>
            <a:r>
              <a:rPr lang="en-US" dirty="0"/>
              <a:t>, M </a:t>
            </a:r>
            <a:r>
              <a:rPr lang="en-US" dirty="0" err="1"/>
              <a:t>Dunkelgrun</a:t>
            </a:r>
            <a:r>
              <a:rPr lang="en-US" dirty="0"/>
              <a:t>, GHEJ </a:t>
            </a:r>
            <a:r>
              <a:rPr lang="en-US" dirty="0" err="1"/>
              <a:t>Vikgen</a:t>
            </a:r>
            <a:r>
              <a:rPr lang="en-US" dirty="0"/>
              <a:t>, </a:t>
            </a:r>
            <a:r>
              <a:rPr lang="en-US" i="1" dirty="0"/>
              <a:t>May 2017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2032445-0623-A84C-A2C0-69350AC39362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384544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5C3EE756-DF6A-4713-89FB-98A46E28C75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2C860C0B-2E9F-49F2-9460-46107BB63EE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66825DCB-86FC-4DA3-AAA0-627B9BBD9C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ACE20-333B-44FF-8048-BDE66E2D3417}" type="datetimeFigureOut">
              <a:rPr lang="it-IT" smtClean="0"/>
              <a:t>09/01/2026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C5987355-6512-4423-AC1B-44E24981C9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E1233452-DDA1-4B3F-9C13-132C5DEA44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63E80D-EAF7-4F5F-BA7C-AA9D8D9D1671}" type="slidenum">
              <a:rPr lang="it-IT" smtClean="0"/>
              <a:t>‹nr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529516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1C7F0807-81D0-4253-B234-B374B0C6067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DC57DABB-378F-4D89-A706-F66973DD9C9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19442D99-3C3A-4B78-BE35-4A3FB9255B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ACE20-333B-44FF-8048-BDE66E2D3417}" type="datetimeFigureOut">
              <a:rPr lang="it-IT" smtClean="0"/>
              <a:t>09/01/2026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FE0E2A6A-BA6C-49EA-8ACD-3324BB1117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54BB33F4-9B5D-430C-B6B8-2BF170C4B6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63E80D-EAF7-4F5F-BA7C-AA9D8D9D1671}" type="slidenum">
              <a:rPr lang="it-IT" smtClean="0"/>
              <a:t>‹nr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131889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4087BF07-E783-4E4B-8E99-782AE0353A4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F20F25FB-97CC-44E1-A9BF-2361087D878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AC3D29A0-66AF-4AC9-BDD4-CCEC785375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ACE20-333B-44FF-8048-BDE66E2D3417}" type="datetimeFigureOut">
              <a:rPr lang="it-IT" smtClean="0"/>
              <a:t>09/01/2026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41B806D9-654B-4B39-ACBB-2178013F60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0A6EF732-C326-4E32-BE60-3B42041F77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63E80D-EAF7-4F5F-BA7C-AA9D8D9D1671}" type="slidenum">
              <a:rPr lang="it-IT" smtClean="0"/>
              <a:t>‹nr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683026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90DCD913-2CE9-47F7-8DF5-B55ADD1012F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700A6B60-4094-4F4D-BD34-EE380470B0D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A5FD9612-5AA2-4662-A788-6D5E9D8366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ACE20-333B-44FF-8048-BDE66E2D3417}" type="datetimeFigureOut">
              <a:rPr lang="it-IT" smtClean="0"/>
              <a:t>09/01/2026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F53694D7-CE1C-425E-97DC-4AF93B8239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125BF268-142F-4DBE-BB43-8764EE7CDF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63E80D-EAF7-4F5F-BA7C-AA9D8D9D1671}" type="slidenum">
              <a:rPr lang="it-IT" smtClean="0"/>
              <a:t>‹nr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421475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D7F7D608-CC5D-4254-A13D-6149D786B65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163DE456-BABE-4339-B81C-0221CB9A73C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B56B46DD-355D-47F9-89D6-3C8FD871FE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ACE20-333B-44FF-8048-BDE66E2D3417}" type="datetimeFigureOut">
              <a:rPr lang="it-IT" smtClean="0"/>
              <a:t>09/01/2026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C932A418-F68D-40C2-B56B-EC7B0CC85E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56304BAF-57B9-4258-97AA-43E4FA100B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63E80D-EAF7-4F5F-BA7C-AA9D8D9D1671}" type="slidenum">
              <a:rPr lang="it-IT" smtClean="0"/>
              <a:t>‹nr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01155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8EDB117F-BC84-42A5-80C3-4D888B6091A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B3478E9A-D498-424D-9EE8-2B0E59BD946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C19E52A5-B8D8-487B-B656-EFCE9EB0A80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FCFA8D9E-F1A2-4B9C-9A32-A9D0783E50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ACE20-333B-44FF-8048-BDE66E2D3417}" type="datetimeFigureOut">
              <a:rPr lang="it-IT" smtClean="0"/>
              <a:t>09/01/2026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5982C0B3-010E-4F67-BAC5-B6226BEB79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A754FCA9-6502-43C3-9124-9FD237787F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63E80D-EAF7-4F5F-BA7C-AA9D8D9D1671}" type="slidenum">
              <a:rPr lang="it-IT" smtClean="0"/>
              <a:t>‹nr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436710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34E98D27-7505-46CB-B8CA-7760BED6AD2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420B258A-83CD-4E3A-A4DC-155F400B05B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0BE29E82-81E4-447F-9030-CF239E877CA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1954D1AA-0AC7-4212-8332-5D5D359139E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95ABE488-E097-45CF-A269-E06BBEE5AB6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D77A92D5-E2FC-4B8D-B28A-733544C12D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ACE20-333B-44FF-8048-BDE66E2D3417}" type="datetimeFigureOut">
              <a:rPr lang="it-IT" smtClean="0"/>
              <a:t>09/01/2026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2B4839BF-D838-4C3D-9567-9797435B85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1C683122-6F71-40F3-9FE4-0E271C1DD7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63E80D-EAF7-4F5F-BA7C-AA9D8D9D1671}" type="slidenum">
              <a:rPr lang="it-IT" smtClean="0"/>
              <a:t>‹nr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086016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9FDB1BDF-B62F-4DD8-8A1C-00717103600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8867A061-5397-43AE-857F-8483161786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ACE20-333B-44FF-8048-BDE66E2D3417}" type="datetimeFigureOut">
              <a:rPr lang="it-IT" smtClean="0"/>
              <a:t>09/01/2026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79BDDE2E-0059-4B34-A48B-D3C8D242CD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50DB4436-B0AA-4133-9FCF-32D245D991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63E80D-EAF7-4F5F-BA7C-AA9D8D9D1671}" type="slidenum">
              <a:rPr lang="it-IT" smtClean="0"/>
              <a:t>‹nr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756902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BA02C732-CCD5-4ADA-B6AD-A92323F50E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ACE20-333B-44FF-8048-BDE66E2D3417}" type="datetimeFigureOut">
              <a:rPr lang="it-IT" smtClean="0"/>
              <a:t>09/01/2026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DD31A62A-4978-4089-8105-BDD96727DB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9F505B86-1899-4229-8FCF-4930257019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63E80D-EAF7-4F5F-BA7C-AA9D8D9D1671}" type="slidenum">
              <a:rPr lang="it-IT" smtClean="0"/>
              <a:t>‹nr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16544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75822F80-6FCE-432B-B81C-621EE802AE6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C738CBAF-9ED8-473F-9938-BC785CD39DC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3D2B786E-0C7B-4C02-9BF9-F64BB8017B2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5CC700F8-1C90-435C-8F29-C932B7D1EB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ACE20-333B-44FF-8048-BDE66E2D3417}" type="datetimeFigureOut">
              <a:rPr lang="it-IT" smtClean="0"/>
              <a:t>09/01/2026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194CDB35-1EDE-41BA-9492-286F1368D1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D60AF755-D296-4197-8C45-EDF1CDA937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63E80D-EAF7-4F5F-BA7C-AA9D8D9D1671}" type="slidenum">
              <a:rPr lang="it-IT" smtClean="0"/>
              <a:t>‹nr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8459332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8A7F0283-8A56-4501-A1BC-4CFA1C9717D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B41ADA50-9ECC-4627-8967-B457905C1E7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80699504-8609-4515-AC65-4B9187F9A26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A1EFFA4E-9FAB-4AB5-96AA-8E05FB8C92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ACE20-333B-44FF-8048-BDE66E2D3417}" type="datetimeFigureOut">
              <a:rPr lang="it-IT" smtClean="0"/>
              <a:t>09/01/2026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61919DB2-E3CE-4DB6-8C6E-6DD387ABEE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0D2811A8-F934-493D-8B84-59CE2D22CF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63E80D-EAF7-4F5F-BA7C-AA9D8D9D1671}" type="slidenum">
              <a:rPr lang="it-IT" smtClean="0"/>
              <a:t>‹nr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237376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108BE410-AACE-489A-830B-919842636CC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2A74C952-12DB-44E4-8E5F-CD7FAB1C85E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13FEA6A1-94CC-4E43-9EB0-CB7BA1DD83D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4ACE20-333B-44FF-8048-BDE66E2D3417}" type="datetimeFigureOut">
              <a:rPr lang="it-IT" smtClean="0"/>
              <a:t>09/01/2026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863ACA87-6133-4DF5-A554-934070FFF8A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CA6DE944-0076-43EB-8EE2-25BA726A93F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63E80D-EAF7-4F5F-BA7C-AA9D8D9D1671}" type="slidenum">
              <a:rPr lang="it-IT" smtClean="0"/>
              <a:t>‹nr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890082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jpe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AE806FAF-9D3E-49D9-BF3D-E9CCC82B410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1201296"/>
            <a:ext cx="10515600" cy="4975667"/>
          </a:xfrm>
        </p:spPr>
        <p:txBody>
          <a:bodyPr/>
          <a:lstStyle/>
          <a:p>
            <a:endParaRPr lang="it-IT" dirty="0"/>
          </a:p>
          <a:p>
            <a:endParaRPr lang="it-IT" dirty="0"/>
          </a:p>
        </p:txBody>
      </p:sp>
      <p:sp>
        <p:nvSpPr>
          <p:cNvPr id="4" name="Rettangolo 3">
            <a:extLst>
              <a:ext uri="{FF2B5EF4-FFF2-40B4-BE49-F238E27FC236}">
                <a16:creationId xmlns:a16="http://schemas.microsoft.com/office/drawing/2014/main" id="{5C047ED4-52E3-4A2A-948B-20CE7D7233A4}"/>
              </a:ext>
            </a:extLst>
          </p:cNvPr>
          <p:cNvSpPr/>
          <p:nvPr/>
        </p:nvSpPr>
        <p:spPr>
          <a:xfrm>
            <a:off x="3888" y="718770"/>
            <a:ext cx="12198272" cy="5090505"/>
          </a:xfrm>
          <a:prstGeom prst="rect">
            <a:avLst/>
          </a:prstGeom>
          <a:solidFill>
            <a:srgbClr val="99B2D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it-IT" sz="2400" b="1"/>
              <a:t>Conclusion</a:t>
            </a:r>
            <a:endParaRPr lang="it-IT" sz="2400" dirty="0"/>
          </a:p>
        </p:txBody>
      </p:sp>
      <p:sp>
        <p:nvSpPr>
          <p:cNvPr id="5" name="Rettangolo 4">
            <a:extLst>
              <a:ext uri="{FF2B5EF4-FFF2-40B4-BE49-F238E27FC236}">
                <a16:creationId xmlns:a16="http://schemas.microsoft.com/office/drawing/2014/main" id="{57C6657B-C862-4624-AF23-0815F276EF35}"/>
              </a:ext>
            </a:extLst>
          </p:cNvPr>
          <p:cNvSpPr/>
          <p:nvPr/>
        </p:nvSpPr>
        <p:spPr>
          <a:xfrm>
            <a:off x="3950889" y="718014"/>
            <a:ext cx="4288076" cy="5090504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dirty="0"/>
          </a:p>
        </p:txBody>
      </p:sp>
      <p:pic>
        <p:nvPicPr>
          <p:cNvPr id="7" name="Immagine 6">
            <a:extLst>
              <a:ext uri="{FF2B5EF4-FFF2-40B4-BE49-F238E27FC236}">
                <a16:creationId xmlns:a16="http://schemas.microsoft.com/office/drawing/2014/main" id="{9D7F0B6B-053D-4EF4-A94B-964FCCCABAE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446763" y="5986009"/>
            <a:ext cx="3425124" cy="714488"/>
          </a:xfrm>
          <a:prstGeom prst="rect">
            <a:avLst/>
          </a:prstGeom>
        </p:spPr>
      </p:pic>
      <p:sp>
        <p:nvSpPr>
          <p:cNvPr id="14" name="CasellaDiTesto 13">
            <a:extLst>
              <a:ext uri="{FF2B5EF4-FFF2-40B4-BE49-F238E27FC236}">
                <a16:creationId xmlns:a16="http://schemas.microsoft.com/office/drawing/2014/main" id="{40F199E0-EF0A-4852-8CD5-FCA17ED84623}"/>
              </a:ext>
            </a:extLst>
          </p:cNvPr>
          <p:cNvSpPr txBox="1"/>
          <p:nvPr/>
        </p:nvSpPr>
        <p:spPr>
          <a:xfrm>
            <a:off x="57233" y="739631"/>
            <a:ext cx="3895804" cy="461665"/>
          </a:xfrm>
          <a:prstGeom prst="rect">
            <a:avLst/>
          </a:prstGeom>
          <a:noFill/>
        </p:spPr>
        <p:txBody>
          <a:bodyPr wrap="square" rtlCol="0" anchor="b">
            <a:spAutoFit/>
          </a:bodyPr>
          <a:lstStyle/>
          <a:p>
            <a:pPr algn="ctr"/>
            <a:r>
              <a:rPr lang="it-IT" sz="2400" b="1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    METHODS</a:t>
            </a:r>
            <a:r>
              <a:rPr lang="it-IT" sz="2400" b="1" dirty="0"/>
              <a:t>	</a:t>
            </a:r>
          </a:p>
        </p:txBody>
      </p:sp>
      <p:sp>
        <p:nvSpPr>
          <p:cNvPr id="18" name="CasellaDiTesto 17">
            <a:extLst>
              <a:ext uri="{FF2B5EF4-FFF2-40B4-BE49-F238E27FC236}">
                <a16:creationId xmlns:a16="http://schemas.microsoft.com/office/drawing/2014/main" id="{F89B844B-5329-4EF8-A25F-1F177F64B210}"/>
              </a:ext>
            </a:extLst>
          </p:cNvPr>
          <p:cNvSpPr txBox="1"/>
          <p:nvPr/>
        </p:nvSpPr>
        <p:spPr>
          <a:xfrm>
            <a:off x="4015144" y="739631"/>
            <a:ext cx="4175760" cy="461665"/>
          </a:xfrm>
          <a:prstGeom prst="rect">
            <a:avLst/>
          </a:prstGeom>
          <a:noFill/>
        </p:spPr>
        <p:txBody>
          <a:bodyPr wrap="square" rtlCol="0" anchor="b">
            <a:spAutoFit/>
          </a:bodyPr>
          <a:lstStyle/>
          <a:p>
            <a:pPr algn="ctr"/>
            <a:r>
              <a:rPr lang="it-IT" sz="2400" b="1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RESULTS</a:t>
            </a:r>
          </a:p>
        </p:txBody>
      </p:sp>
      <p:pic>
        <p:nvPicPr>
          <p:cNvPr id="6" name="Immagine 5">
            <a:extLst>
              <a:ext uri="{FF2B5EF4-FFF2-40B4-BE49-F238E27FC236}">
                <a16:creationId xmlns:a16="http://schemas.microsoft.com/office/drawing/2014/main" id="{E2FD73DB-5170-483D-8AED-73807F7EFBA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20113" y="5959626"/>
            <a:ext cx="2422604" cy="699863"/>
          </a:xfrm>
          <a:prstGeom prst="rect">
            <a:avLst/>
          </a:prstGeom>
          <a:ln>
            <a:noFill/>
          </a:ln>
        </p:spPr>
      </p:pic>
      <p:sp>
        <p:nvSpPr>
          <p:cNvPr id="11" name="CasellaDiTesto 10">
            <a:extLst>
              <a:ext uri="{FF2B5EF4-FFF2-40B4-BE49-F238E27FC236}">
                <a16:creationId xmlns:a16="http://schemas.microsoft.com/office/drawing/2014/main" id="{7E841DD3-FD98-4EB0-9BD3-D2A17CABA7C9}"/>
              </a:ext>
            </a:extLst>
          </p:cNvPr>
          <p:cNvSpPr txBox="1"/>
          <p:nvPr/>
        </p:nvSpPr>
        <p:spPr>
          <a:xfrm>
            <a:off x="10160" y="-11017"/>
            <a:ext cx="11861727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b="1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Extended versus standard pouch in Roux-en-Y gastric bypass: nine-year follow-up results of a randomized controlled trial	</a:t>
            </a:r>
            <a:endParaRPr lang="en-US" sz="2800" b="1" dirty="0"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  <p:sp>
        <p:nvSpPr>
          <p:cNvPr id="127" name="Rectangle 126"/>
          <p:cNvSpPr/>
          <p:nvPr/>
        </p:nvSpPr>
        <p:spPr>
          <a:xfrm>
            <a:off x="8126650" y="739631"/>
            <a:ext cx="4065350" cy="461665"/>
          </a:xfrm>
          <a:prstGeom prst="rect">
            <a:avLst/>
          </a:prstGeom>
        </p:spPr>
        <p:txBody>
          <a:bodyPr wrap="square" anchor="b">
            <a:spAutoFit/>
          </a:bodyPr>
          <a:lstStyle/>
          <a:p>
            <a:pPr algn="ctr"/>
            <a:r>
              <a:rPr lang="it-IT" sz="2400" b="1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CONCLUSIONS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105B06F1-4FC1-406F-9F3D-BE586F3167B6}"/>
              </a:ext>
            </a:extLst>
          </p:cNvPr>
          <p:cNvSpPr txBox="1"/>
          <p:nvPr/>
        </p:nvSpPr>
        <p:spPr>
          <a:xfrm>
            <a:off x="2852929" y="5986009"/>
            <a:ext cx="5449824" cy="738664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endParaRPr lang="en-US" sz="1400" dirty="0"/>
          </a:p>
          <a:p>
            <a:pPr algn="ctr"/>
            <a:endParaRPr lang="en-US" sz="1400" dirty="0"/>
          </a:p>
          <a:p>
            <a:pPr algn="ctr"/>
            <a:endParaRPr lang="en-US" sz="1400" dirty="0"/>
          </a:p>
        </p:txBody>
      </p:sp>
      <p:pic>
        <p:nvPicPr>
          <p:cNvPr id="23" name="Afbeelding 22">
            <a:extLst>
              <a:ext uri="{FF2B5EF4-FFF2-40B4-BE49-F238E27FC236}">
                <a16:creationId xmlns:a16="http://schemas.microsoft.com/office/drawing/2014/main" id="{B070DF84-7CB3-635F-D661-83C8E9A22F8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41537" y="2151341"/>
            <a:ext cx="3113901" cy="2075934"/>
          </a:xfrm>
          <a:prstGeom prst="rect">
            <a:avLst/>
          </a:prstGeom>
        </p:spPr>
      </p:pic>
      <p:sp>
        <p:nvSpPr>
          <p:cNvPr id="24" name="Tekstvak 23">
            <a:extLst>
              <a:ext uri="{FF2B5EF4-FFF2-40B4-BE49-F238E27FC236}">
                <a16:creationId xmlns:a16="http://schemas.microsoft.com/office/drawing/2014/main" id="{E3B61A29-FE84-1C98-59F6-CEDFBBDC164E}"/>
              </a:ext>
            </a:extLst>
          </p:cNvPr>
          <p:cNvSpPr txBox="1"/>
          <p:nvPr/>
        </p:nvSpPr>
        <p:spPr>
          <a:xfrm>
            <a:off x="632194" y="1303519"/>
            <a:ext cx="3140097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/>
              <a:t>Follow-up study of a single-blinded RCT including 62 patients </a:t>
            </a:r>
          </a:p>
        </p:txBody>
      </p:sp>
      <p:sp>
        <p:nvSpPr>
          <p:cNvPr id="25" name="Gelijkbenige driehoek 24">
            <a:extLst>
              <a:ext uri="{FF2B5EF4-FFF2-40B4-BE49-F238E27FC236}">
                <a16:creationId xmlns:a16="http://schemas.microsoft.com/office/drawing/2014/main" id="{D1B2D1EC-EF45-5460-5C5A-11127F41EF19}"/>
              </a:ext>
            </a:extLst>
          </p:cNvPr>
          <p:cNvSpPr/>
          <p:nvPr/>
        </p:nvSpPr>
        <p:spPr>
          <a:xfrm rot="10800000">
            <a:off x="1822429" y="1939083"/>
            <a:ext cx="314793" cy="170495"/>
          </a:xfrm>
          <a:prstGeom prst="triangl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" name="Rechthoek: afgeronde hoeken 25">
            <a:extLst>
              <a:ext uri="{FF2B5EF4-FFF2-40B4-BE49-F238E27FC236}">
                <a16:creationId xmlns:a16="http://schemas.microsoft.com/office/drawing/2014/main" id="{BB5469D2-C52B-98B3-2B4C-FBB86B197C0D}"/>
              </a:ext>
            </a:extLst>
          </p:cNvPr>
          <p:cNvSpPr/>
          <p:nvPr/>
        </p:nvSpPr>
        <p:spPr>
          <a:xfrm>
            <a:off x="413836" y="4058781"/>
            <a:ext cx="1457867" cy="372766"/>
          </a:xfrm>
          <a:prstGeom prst="roundRect">
            <a:avLst/>
          </a:prstGeom>
          <a:solidFill>
            <a:schemeClr val="accent3">
              <a:lumMod val="60000"/>
              <a:lumOff val="40000"/>
            </a:schemeClr>
          </a:solidFill>
        </p:spPr>
        <p:style>
          <a:lnRef idx="2">
            <a:schemeClr val="accent5">
              <a:shade val="50000"/>
            </a:schemeClr>
          </a:lnRef>
          <a:fillRef idx="1">
            <a:schemeClr val="accent5"/>
          </a:fillRef>
          <a:effectRef idx="0">
            <a:schemeClr val="accent5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dirty="0">
                <a:solidFill>
                  <a:sysClr val="windowText" lastClr="000000"/>
                </a:solidFill>
              </a:rPr>
              <a:t>  Standard RYGB</a:t>
            </a:r>
            <a:endParaRPr lang="en-US" sz="1400" b="1" dirty="0">
              <a:solidFill>
                <a:sysClr val="windowText" lastClr="000000"/>
              </a:solidFill>
            </a:endParaRPr>
          </a:p>
        </p:txBody>
      </p:sp>
      <p:sp>
        <p:nvSpPr>
          <p:cNvPr id="27" name="Rechthoek: afgeronde hoeken 26">
            <a:extLst>
              <a:ext uri="{FF2B5EF4-FFF2-40B4-BE49-F238E27FC236}">
                <a16:creationId xmlns:a16="http://schemas.microsoft.com/office/drawing/2014/main" id="{0F44C84C-2A81-6570-4A59-0766BE5156B9}"/>
              </a:ext>
            </a:extLst>
          </p:cNvPr>
          <p:cNvSpPr/>
          <p:nvPr/>
        </p:nvSpPr>
        <p:spPr>
          <a:xfrm>
            <a:off x="2070593" y="4058781"/>
            <a:ext cx="1457867" cy="372766"/>
          </a:xfrm>
          <a:prstGeom prst="roundRect">
            <a:avLst/>
          </a:prstGeom>
          <a:solidFill>
            <a:schemeClr val="accent3">
              <a:lumMod val="60000"/>
              <a:lumOff val="40000"/>
            </a:schemeClr>
          </a:solidFill>
        </p:spPr>
        <p:style>
          <a:lnRef idx="2">
            <a:schemeClr val="accent5">
              <a:shade val="50000"/>
            </a:schemeClr>
          </a:lnRef>
          <a:fillRef idx="1">
            <a:schemeClr val="accent5"/>
          </a:fillRef>
          <a:effectRef idx="0">
            <a:schemeClr val="accent5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dirty="0">
                <a:solidFill>
                  <a:sysClr val="windowText" lastClr="000000"/>
                </a:solidFill>
              </a:rPr>
              <a:t>  Extend pouch RYGB</a:t>
            </a:r>
            <a:endParaRPr lang="en-US" sz="1400" b="1" dirty="0">
              <a:solidFill>
                <a:sysClr val="windowText" lastClr="000000"/>
              </a:solidFill>
            </a:endParaRPr>
          </a:p>
        </p:txBody>
      </p:sp>
      <p:sp>
        <p:nvSpPr>
          <p:cNvPr id="28" name="Tekstvak 27">
            <a:extLst>
              <a:ext uri="{FF2B5EF4-FFF2-40B4-BE49-F238E27FC236}">
                <a16:creationId xmlns:a16="http://schemas.microsoft.com/office/drawing/2014/main" id="{7133CA99-0010-BEDB-72F7-BEE2FF898C2A}"/>
              </a:ext>
            </a:extLst>
          </p:cNvPr>
          <p:cNvSpPr txBox="1"/>
          <p:nvPr/>
        </p:nvSpPr>
        <p:spPr>
          <a:xfrm>
            <a:off x="1680831" y="4101996"/>
            <a:ext cx="60163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/>
              <a:t>vs</a:t>
            </a:r>
          </a:p>
        </p:txBody>
      </p:sp>
      <p:sp>
        <p:nvSpPr>
          <p:cNvPr id="29" name="Gelijkbenige driehoek 28">
            <a:extLst>
              <a:ext uri="{FF2B5EF4-FFF2-40B4-BE49-F238E27FC236}">
                <a16:creationId xmlns:a16="http://schemas.microsoft.com/office/drawing/2014/main" id="{704A9419-7C24-62ED-881C-79C46C5E8190}"/>
              </a:ext>
            </a:extLst>
          </p:cNvPr>
          <p:cNvSpPr/>
          <p:nvPr/>
        </p:nvSpPr>
        <p:spPr>
          <a:xfrm rot="10800000">
            <a:off x="1847738" y="4571832"/>
            <a:ext cx="314793" cy="170495"/>
          </a:xfrm>
          <a:prstGeom prst="triangl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" name="Tekstvak 29">
            <a:extLst>
              <a:ext uri="{FF2B5EF4-FFF2-40B4-BE49-F238E27FC236}">
                <a16:creationId xmlns:a16="http://schemas.microsoft.com/office/drawing/2014/main" id="{1CB6E54D-5C62-4266-C3B7-FED6878E76A7}"/>
              </a:ext>
            </a:extLst>
          </p:cNvPr>
          <p:cNvSpPr txBox="1"/>
          <p:nvPr/>
        </p:nvSpPr>
        <p:spPr>
          <a:xfrm>
            <a:off x="107322" y="4786254"/>
            <a:ext cx="3843567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/>
              <a:t>Nine-year outcomes on weight loss, obesity related complications and patient-reported health-related quality of life</a:t>
            </a:r>
          </a:p>
        </p:txBody>
      </p:sp>
      <p:pic>
        <p:nvPicPr>
          <p:cNvPr id="31" name="Afbeelding 30">
            <a:extLst>
              <a:ext uri="{FF2B5EF4-FFF2-40B4-BE49-F238E27FC236}">
                <a16:creationId xmlns:a16="http://schemas.microsoft.com/office/drawing/2014/main" id="{82D351CE-3A2D-9710-548A-AEF418897828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7237"/>
          <a:stretch/>
        </p:blipFill>
        <p:spPr bwMode="auto">
          <a:xfrm>
            <a:off x="4562701" y="2465775"/>
            <a:ext cx="3320990" cy="1675348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32" name="Rechthoek: afgeronde hoeken 31">
            <a:extLst>
              <a:ext uri="{FF2B5EF4-FFF2-40B4-BE49-F238E27FC236}">
                <a16:creationId xmlns:a16="http://schemas.microsoft.com/office/drawing/2014/main" id="{D2CEB771-5125-69A0-6453-E2334BFF5D1F}"/>
              </a:ext>
            </a:extLst>
          </p:cNvPr>
          <p:cNvSpPr/>
          <p:nvPr/>
        </p:nvSpPr>
        <p:spPr>
          <a:xfrm>
            <a:off x="4255714" y="1978536"/>
            <a:ext cx="1313518" cy="307314"/>
          </a:xfrm>
          <a:prstGeom prst="roundRect">
            <a:avLst/>
          </a:prstGeom>
          <a:solidFill>
            <a:schemeClr val="accent1">
              <a:lumMod val="40000"/>
              <a:lumOff val="60000"/>
            </a:schemeClr>
          </a:solidFill>
        </p:spPr>
        <p:style>
          <a:lnRef idx="2">
            <a:schemeClr val="accent5">
              <a:shade val="50000"/>
            </a:schemeClr>
          </a:lnRef>
          <a:fillRef idx="1">
            <a:schemeClr val="accent5"/>
          </a:fillRef>
          <a:effectRef idx="0">
            <a:schemeClr val="accent5"/>
          </a:effectRef>
          <a:fontRef idx="minor">
            <a:schemeClr val="lt1"/>
          </a:fontRef>
        </p:style>
        <p:txBody>
          <a:bodyPr rtlCol="0" anchor="ctr"/>
          <a:lstStyle/>
          <a:p>
            <a:pPr algn="r"/>
            <a:r>
              <a:rPr lang="en-US" sz="1400" dirty="0">
                <a:solidFill>
                  <a:schemeClr val="bg1"/>
                </a:solidFill>
              </a:rPr>
              <a:t>  Weight loss</a:t>
            </a:r>
            <a:endParaRPr lang="en-US" sz="1400" b="1" dirty="0">
              <a:solidFill>
                <a:schemeClr val="bg1"/>
              </a:solidFill>
            </a:endParaRPr>
          </a:p>
        </p:txBody>
      </p:sp>
      <p:sp>
        <p:nvSpPr>
          <p:cNvPr id="33" name="Pijl: omlaag 32">
            <a:extLst>
              <a:ext uri="{FF2B5EF4-FFF2-40B4-BE49-F238E27FC236}">
                <a16:creationId xmlns:a16="http://schemas.microsoft.com/office/drawing/2014/main" id="{7240DAAE-BB03-C24F-7FA4-BBB2A9A26EE8}"/>
              </a:ext>
            </a:extLst>
          </p:cNvPr>
          <p:cNvSpPr/>
          <p:nvPr/>
        </p:nvSpPr>
        <p:spPr>
          <a:xfrm rot="10800000">
            <a:off x="4172928" y="1893884"/>
            <a:ext cx="321145" cy="435803"/>
          </a:xfrm>
          <a:prstGeom prst="downArrow">
            <a:avLst/>
          </a:prstGeom>
        </p:spPr>
        <p:style>
          <a:lnRef idx="2">
            <a:schemeClr val="accent6">
              <a:shade val="50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4" name="Rechthoek: afgeronde hoeken 33">
            <a:extLst>
              <a:ext uri="{FF2B5EF4-FFF2-40B4-BE49-F238E27FC236}">
                <a16:creationId xmlns:a16="http://schemas.microsoft.com/office/drawing/2014/main" id="{D3984141-7FB9-BD38-A6B8-B83AEE9F95B7}"/>
              </a:ext>
            </a:extLst>
          </p:cNvPr>
          <p:cNvSpPr/>
          <p:nvPr/>
        </p:nvSpPr>
        <p:spPr>
          <a:xfrm>
            <a:off x="4181261" y="1419009"/>
            <a:ext cx="1457867" cy="372766"/>
          </a:xfrm>
          <a:prstGeom prst="roundRect">
            <a:avLst/>
          </a:prstGeom>
          <a:solidFill>
            <a:schemeClr val="accent3">
              <a:lumMod val="60000"/>
              <a:lumOff val="40000"/>
            </a:schemeClr>
          </a:solidFill>
        </p:spPr>
        <p:style>
          <a:lnRef idx="2">
            <a:schemeClr val="accent5">
              <a:shade val="50000"/>
            </a:schemeClr>
          </a:lnRef>
          <a:fillRef idx="1">
            <a:schemeClr val="accent5"/>
          </a:fillRef>
          <a:effectRef idx="0">
            <a:schemeClr val="accent5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dirty="0">
                <a:solidFill>
                  <a:sysClr val="windowText" lastClr="000000"/>
                </a:solidFill>
              </a:rPr>
              <a:t>  Standard RYGB</a:t>
            </a:r>
            <a:endParaRPr lang="en-US" sz="1400" b="1" dirty="0">
              <a:solidFill>
                <a:sysClr val="windowText" lastClr="000000"/>
              </a:solidFill>
            </a:endParaRPr>
          </a:p>
        </p:txBody>
      </p:sp>
      <p:sp>
        <p:nvSpPr>
          <p:cNvPr id="35" name="Rechthoek: afgeronde hoeken 34">
            <a:extLst>
              <a:ext uri="{FF2B5EF4-FFF2-40B4-BE49-F238E27FC236}">
                <a16:creationId xmlns:a16="http://schemas.microsoft.com/office/drawing/2014/main" id="{BD551973-20FE-AB39-5B53-1991DB90A4F5}"/>
              </a:ext>
            </a:extLst>
          </p:cNvPr>
          <p:cNvSpPr/>
          <p:nvPr/>
        </p:nvSpPr>
        <p:spPr>
          <a:xfrm>
            <a:off x="6566393" y="1420085"/>
            <a:ext cx="1457867" cy="372766"/>
          </a:xfrm>
          <a:prstGeom prst="roundRect">
            <a:avLst/>
          </a:prstGeom>
          <a:solidFill>
            <a:schemeClr val="accent3">
              <a:lumMod val="60000"/>
              <a:lumOff val="40000"/>
            </a:schemeClr>
          </a:solidFill>
        </p:spPr>
        <p:style>
          <a:lnRef idx="2">
            <a:schemeClr val="accent5">
              <a:shade val="50000"/>
            </a:schemeClr>
          </a:lnRef>
          <a:fillRef idx="1">
            <a:schemeClr val="accent5"/>
          </a:fillRef>
          <a:effectRef idx="0">
            <a:schemeClr val="accent5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dirty="0">
                <a:solidFill>
                  <a:sysClr val="windowText" lastClr="000000"/>
                </a:solidFill>
              </a:rPr>
              <a:t>  Extend pouch RYGB</a:t>
            </a:r>
            <a:endParaRPr lang="en-US" sz="1400" b="1" dirty="0">
              <a:solidFill>
                <a:sysClr val="windowText" lastClr="000000"/>
              </a:solidFill>
            </a:endParaRPr>
          </a:p>
        </p:txBody>
      </p:sp>
      <p:sp>
        <p:nvSpPr>
          <p:cNvPr id="36" name="Tekstvak 35">
            <a:extLst>
              <a:ext uri="{FF2B5EF4-FFF2-40B4-BE49-F238E27FC236}">
                <a16:creationId xmlns:a16="http://schemas.microsoft.com/office/drawing/2014/main" id="{348C7529-2995-53B1-D538-033AD1790640}"/>
              </a:ext>
            </a:extLst>
          </p:cNvPr>
          <p:cNvSpPr txBox="1"/>
          <p:nvPr/>
        </p:nvSpPr>
        <p:spPr>
          <a:xfrm>
            <a:off x="5801942" y="1485074"/>
            <a:ext cx="60163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/>
              <a:t>vs</a:t>
            </a:r>
          </a:p>
        </p:txBody>
      </p:sp>
      <p:sp>
        <p:nvSpPr>
          <p:cNvPr id="37" name="Rechthoek: afgeronde hoeken 36">
            <a:extLst>
              <a:ext uri="{FF2B5EF4-FFF2-40B4-BE49-F238E27FC236}">
                <a16:creationId xmlns:a16="http://schemas.microsoft.com/office/drawing/2014/main" id="{C9E1EA57-6D8A-1D64-77E9-A126FD5D8F93}"/>
              </a:ext>
            </a:extLst>
          </p:cNvPr>
          <p:cNvSpPr/>
          <p:nvPr/>
        </p:nvSpPr>
        <p:spPr>
          <a:xfrm>
            <a:off x="4984392" y="4435013"/>
            <a:ext cx="2503110" cy="307314"/>
          </a:xfrm>
          <a:prstGeom prst="roundRect">
            <a:avLst/>
          </a:prstGeom>
          <a:solidFill>
            <a:schemeClr val="accent1">
              <a:lumMod val="40000"/>
              <a:lumOff val="60000"/>
            </a:schemeClr>
          </a:solidFill>
        </p:spPr>
        <p:style>
          <a:lnRef idx="2">
            <a:schemeClr val="accent5">
              <a:shade val="50000"/>
            </a:schemeClr>
          </a:lnRef>
          <a:fillRef idx="1">
            <a:schemeClr val="accent5"/>
          </a:fillRef>
          <a:effectRef idx="0">
            <a:schemeClr val="accent5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dirty="0">
                <a:solidFill>
                  <a:schemeClr val="bg1"/>
                </a:solidFill>
              </a:rPr>
              <a:t>  Obesity related complications       </a:t>
            </a:r>
            <a:endParaRPr lang="en-US" sz="1400" b="1" dirty="0">
              <a:solidFill>
                <a:schemeClr val="bg1"/>
              </a:solidFill>
            </a:endParaRPr>
          </a:p>
        </p:txBody>
      </p:sp>
      <p:sp>
        <p:nvSpPr>
          <p:cNvPr id="39" name="Is gelijk aan 38">
            <a:extLst>
              <a:ext uri="{FF2B5EF4-FFF2-40B4-BE49-F238E27FC236}">
                <a16:creationId xmlns:a16="http://schemas.microsoft.com/office/drawing/2014/main" id="{FE5E2807-64B4-8D7B-90D9-0214159A81E5}"/>
              </a:ext>
            </a:extLst>
          </p:cNvPr>
          <p:cNvSpPr/>
          <p:nvPr/>
        </p:nvSpPr>
        <p:spPr>
          <a:xfrm>
            <a:off x="4712061" y="4402731"/>
            <a:ext cx="454675" cy="379116"/>
          </a:xfrm>
          <a:prstGeom prst="mathEqual">
            <a:avLst/>
          </a:prstGeom>
          <a:solidFill>
            <a:schemeClr val="bg2">
              <a:lumMod val="90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nl-NL" dirty="0">
                <a:solidFill>
                  <a:schemeClr val="tx1"/>
                </a:solidFill>
              </a:rPr>
              <a:t>         </a:t>
            </a:r>
          </a:p>
        </p:txBody>
      </p:sp>
      <p:sp>
        <p:nvSpPr>
          <p:cNvPr id="42" name="Rechthoek: afgeronde hoeken 41">
            <a:extLst>
              <a:ext uri="{FF2B5EF4-FFF2-40B4-BE49-F238E27FC236}">
                <a16:creationId xmlns:a16="http://schemas.microsoft.com/office/drawing/2014/main" id="{25472ADC-4759-7048-FE14-5431AEB3E2BC}"/>
              </a:ext>
            </a:extLst>
          </p:cNvPr>
          <p:cNvSpPr/>
          <p:nvPr/>
        </p:nvSpPr>
        <p:spPr>
          <a:xfrm>
            <a:off x="4977979" y="4839851"/>
            <a:ext cx="2503110" cy="307314"/>
          </a:xfrm>
          <a:prstGeom prst="roundRect">
            <a:avLst/>
          </a:prstGeom>
          <a:solidFill>
            <a:schemeClr val="accent1">
              <a:lumMod val="40000"/>
              <a:lumOff val="60000"/>
            </a:schemeClr>
          </a:solidFill>
        </p:spPr>
        <p:style>
          <a:lnRef idx="2">
            <a:schemeClr val="accent5">
              <a:shade val="50000"/>
            </a:schemeClr>
          </a:lnRef>
          <a:fillRef idx="1">
            <a:schemeClr val="accent5"/>
          </a:fillRef>
          <a:effectRef idx="0">
            <a:schemeClr val="accent5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dirty="0">
                <a:solidFill>
                  <a:schemeClr val="bg1"/>
                </a:solidFill>
              </a:rPr>
              <a:t>Health-related quality of life</a:t>
            </a:r>
            <a:endParaRPr lang="en-US" sz="1400" b="1" dirty="0">
              <a:solidFill>
                <a:schemeClr val="bg1"/>
              </a:solidFill>
            </a:endParaRPr>
          </a:p>
        </p:txBody>
      </p:sp>
      <p:sp>
        <p:nvSpPr>
          <p:cNvPr id="43" name="Is gelijk aan 42">
            <a:extLst>
              <a:ext uri="{FF2B5EF4-FFF2-40B4-BE49-F238E27FC236}">
                <a16:creationId xmlns:a16="http://schemas.microsoft.com/office/drawing/2014/main" id="{2394371F-8A33-89BB-983F-46571C1C1992}"/>
              </a:ext>
            </a:extLst>
          </p:cNvPr>
          <p:cNvSpPr/>
          <p:nvPr/>
        </p:nvSpPr>
        <p:spPr>
          <a:xfrm>
            <a:off x="4705648" y="4807569"/>
            <a:ext cx="454675" cy="379116"/>
          </a:xfrm>
          <a:prstGeom prst="mathEqual">
            <a:avLst/>
          </a:prstGeom>
          <a:solidFill>
            <a:schemeClr val="bg2">
              <a:lumMod val="90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nl-NL" dirty="0">
                <a:solidFill>
                  <a:schemeClr val="tx1"/>
                </a:solidFill>
              </a:rPr>
              <a:t>         </a:t>
            </a:r>
          </a:p>
        </p:txBody>
      </p:sp>
      <p:sp>
        <p:nvSpPr>
          <p:cNvPr id="44" name="Tekstvak 43">
            <a:extLst>
              <a:ext uri="{FF2B5EF4-FFF2-40B4-BE49-F238E27FC236}">
                <a16:creationId xmlns:a16="http://schemas.microsoft.com/office/drawing/2014/main" id="{61B74AB0-3A4D-F8C2-8CA6-789B7323E54F}"/>
              </a:ext>
            </a:extLst>
          </p:cNvPr>
          <p:cNvSpPr txBox="1"/>
          <p:nvPr/>
        </p:nvSpPr>
        <p:spPr>
          <a:xfrm>
            <a:off x="8238965" y="1748397"/>
            <a:ext cx="3912236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/>
              <a:t>Extended Pouch Roux-en-Y Gastric Bypass showed slightly better weight loss results compared to Standard Roux-en-Y Gastric Bypass</a:t>
            </a:r>
          </a:p>
        </p:txBody>
      </p:sp>
      <p:sp>
        <p:nvSpPr>
          <p:cNvPr id="45" name="Gelijkbenige driehoek 44">
            <a:extLst>
              <a:ext uri="{FF2B5EF4-FFF2-40B4-BE49-F238E27FC236}">
                <a16:creationId xmlns:a16="http://schemas.microsoft.com/office/drawing/2014/main" id="{491F5F53-1CBA-E2B7-3F25-4DFE8350AF0D}"/>
              </a:ext>
            </a:extLst>
          </p:cNvPr>
          <p:cNvSpPr/>
          <p:nvPr/>
        </p:nvSpPr>
        <p:spPr>
          <a:xfrm rot="10800000">
            <a:off x="10037686" y="2916886"/>
            <a:ext cx="314793" cy="170495"/>
          </a:xfrm>
          <a:prstGeom prst="triangl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6" name="Tekstvak 45">
            <a:extLst>
              <a:ext uri="{FF2B5EF4-FFF2-40B4-BE49-F238E27FC236}">
                <a16:creationId xmlns:a16="http://schemas.microsoft.com/office/drawing/2014/main" id="{A2B591DB-E2D8-7C8D-AF13-2F7467B64E33}"/>
              </a:ext>
            </a:extLst>
          </p:cNvPr>
          <p:cNvSpPr txBox="1"/>
          <p:nvPr/>
        </p:nvSpPr>
        <p:spPr>
          <a:xfrm>
            <a:off x="8238965" y="4143940"/>
            <a:ext cx="3912236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/>
              <a:t>No definitive conclusions can be drawn from this study due to loss of power and the findings should be regarded as exploratory</a:t>
            </a:r>
          </a:p>
        </p:txBody>
      </p:sp>
      <p:sp>
        <p:nvSpPr>
          <p:cNvPr id="48" name="Tekstvak 47">
            <a:extLst>
              <a:ext uri="{FF2B5EF4-FFF2-40B4-BE49-F238E27FC236}">
                <a16:creationId xmlns:a16="http://schemas.microsoft.com/office/drawing/2014/main" id="{62534CFD-2526-7FB1-D2D1-7CABA8E4DA7C}"/>
              </a:ext>
            </a:extLst>
          </p:cNvPr>
          <p:cNvSpPr txBox="1"/>
          <p:nvPr/>
        </p:nvSpPr>
        <p:spPr>
          <a:xfrm>
            <a:off x="8280039" y="3095697"/>
            <a:ext cx="3912236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/>
              <a:t>Patients who underwent Standard Roux-en-Y Gastric bypass were more prone to developing recurrent weight gain</a:t>
            </a:r>
          </a:p>
        </p:txBody>
      </p:sp>
      <p:sp>
        <p:nvSpPr>
          <p:cNvPr id="49" name="Gelijkbenige driehoek 48">
            <a:extLst>
              <a:ext uri="{FF2B5EF4-FFF2-40B4-BE49-F238E27FC236}">
                <a16:creationId xmlns:a16="http://schemas.microsoft.com/office/drawing/2014/main" id="{5D845F31-7F20-A733-E64C-4300D51C089D}"/>
              </a:ext>
            </a:extLst>
          </p:cNvPr>
          <p:cNvSpPr/>
          <p:nvPr/>
        </p:nvSpPr>
        <p:spPr>
          <a:xfrm rot="10800000">
            <a:off x="10027323" y="3927536"/>
            <a:ext cx="314793" cy="170495"/>
          </a:xfrm>
          <a:prstGeom prst="triangl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9068927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26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8" fill="hold">
                      <p:stCondLst>
                        <p:cond delay="indefinite"/>
                      </p:stCondLst>
                      <p:childTnLst>
                        <p:par>
                          <p:cTn id="9" fill="hold">
                            <p:stCondLst>
                              <p:cond delay="0"/>
                            </p:stCondLst>
                            <p:childTnLst>
                              <p:par>
                                <p:cTn id="10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2" dur="500"/>
                                        <p:tgtEl>
                                          <p:spTgt spid="27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3" fill="hold">
                      <p:stCondLst>
                        <p:cond delay="indefinite"/>
                      </p:stCondLst>
                      <p:childTnLst>
                        <p:par>
                          <p:cTn id="14" fill="hold">
                            <p:stCondLst>
                              <p:cond delay="0"/>
                            </p:stCondLst>
                            <p:childTnLst>
                              <p:par>
                                <p:cTn id="15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7" dur="500"/>
                                        <p:tgtEl>
                                          <p:spTgt spid="32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8" fill="hold">
                      <p:stCondLst>
                        <p:cond delay="indefinite"/>
                      </p:stCondLst>
                      <p:childTnLst>
                        <p:par>
                          <p:cTn id="19" fill="hold">
                            <p:stCondLst>
                              <p:cond delay="0"/>
                            </p:stCondLst>
                            <p:childTnLst>
                              <p:par>
                                <p:cTn id="20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2" dur="500"/>
                                        <p:tgtEl>
                                          <p:spTgt spid="3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3" fill="hold">
                      <p:stCondLst>
                        <p:cond delay="indefinite"/>
                      </p:stCondLst>
                      <p:childTnLst>
                        <p:par>
                          <p:cTn id="24" fill="hold">
                            <p:stCondLst>
                              <p:cond delay="0"/>
                            </p:stCondLst>
                            <p:childTnLst>
                              <p:par>
                                <p:cTn id="25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7" dur="500"/>
                                        <p:tgtEl>
                                          <p:spTgt spid="3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8" fill="hold">
                      <p:stCondLst>
                        <p:cond delay="indefinite"/>
                      </p:stCondLst>
                      <p:childTnLst>
                        <p:par>
                          <p:cTn id="29" fill="hold">
                            <p:stCondLst>
                              <p:cond delay="0"/>
                            </p:stCondLst>
                            <p:childTnLst>
                              <p:par>
                                <p:cTn id="30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32" dur="500"/>
                                        <p:tgtEl>
                                          <p:spTgt spid="37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3" fill="hold">
                      <p:stCondLst>
                        <p:cond delay="indefinite"/>
                      </p:stCondLst>
                      <p:childTnLst>
                        <p:par>
                          <p:cTn id="34" fill="hold">
                            <p:stCondLst>
                              <p:cond delay="0"/>
                            </p:stCondLst>
                            <p:childTnLst>
                              <p:par>
                                <p:cTn id="35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37" dur="500"/>
                                        <p:tgtEl>
                                          <p:spTgt spid="42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26" grpId="0" animBg="1"/>
      <p:bldP spid="27" grpId="0" animBg="1"/>
      <p:bldP spid="32" grpId="0" animBg="1"/>
      <p:bldP spid="34" grpId="0" animBg="1"/>
      <p:bldP spid="35" grpId="0" animBg="1"/>
      <p:bldP spid="37" grpId="0" animBg="1"/>
      <p:bldP spid="42" grpId="0" animBg="1"/>
    </p:bldLst>
  </p:timing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7d494ce6-7da9-4269-988c-cd0648e54523">
      <Terms xmlns="http://schemas.microsoft.com/office/infopath/2007/PartnerControls"/>
    </lcf76f155ced4ddcb4097134ff3c332f>
  </documentManagement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1C9D8233362EC04098325F441C5BC7E7" ma:contentTypeVersion="12" ma:contentTypeDescription="Een nieuw document maken." ma:contentTypeScope="" ma:versionID="7434af0ae3af20adb7b2a8b21252c556">
  <xsd:schema xmlns:xsd="http://www.w3.org/2001/XMLSchema" xmlns:xs="http://www.w3.org/2001/XMLSchema" xmlns:p="http://schemas.microsoft.com/office/2006/metadata/properties" xmlns:ns2="7d494ce6-7da9-4269-988c-cd0648e54523" targetNamespace="http://schemas.microsoft.com/office/2006/metadata/properties" ma:root="true" ma:fieldsID="d5e5255d0f6410f74016f4649885971d" ns2:_="">
    <xsd:import namespace="7d494ce6-7da9-4269-988c-cd0648e54523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SearchProperties" minOccurs="0"/>
                <xsd:element ref="ns2:MediaServiceDateTaken" minOccurs="0"/>
                <xsd:element ref="ns2:MediaServiceGenerationTime" minOccurs="0"/>
                <xsd:element ref="ns2:MediaServiceEventHashCode" minOccurs="0"/>
                <xsd:element ref="ns2:MediaLengthInSeconds" minOccurs="0"/>
                <xsd:element ref="ns2:lcf76f155ced4ddcb4097134ff3c332f" minOccurs="0"/>
                <xsd:element ref="ns2:MediaServiceBillingMetadata" minOccurs="0"/>
                <xsd:element ref="ns2:MediaServiceOCR" minOccurs="0"/>
                <xsd:element ref="ns2:MediaServiceLocation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7d494ce6-7da9-4269-988c-cd0648e54523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SearchProperties" ma:index="10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MediaServiceDateTaken" ma:index="11" nillable="true" ma:displayName="MediaServiceDateTaken" ma:hidden="true" ma:indexed="true" ma:internalName="MediaServiceDateTaken" ma:readOnly="true">
      <xsd:simpleType>
        <xsd:restriction base="dms:Text"/>
      </xsd:simpleType>
    </xsd:element>
    <xsd:element name="MediaServiceGenerationTime" ma:index="12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3" nillable="true" ma:displayName="MediaServiceEventHashCode" ma:hidden="true" ma:internalName="MediaServiceEventHashCode" ma:readOnly="true">
      <xsd:simpleType>
        <xsd:restriction base="dms:Text"/>
      </xsd:simpleType>
    </xsd:element>
    <xsd:element name="MediaLengthInSeconds" ma:index="14" nillable="true" ma:displayName="MediaLengthInSeconds" ma:hidden="true" ma:internalName="MediaLengthInSeconds" ma:readOnly="true">
      <xsd:simpleType>
        <xsd:restriction base="dms:Unknown"/>
      </xsd:simpleType>
    </xsd:element>
    <xsd:element name="lcf76f155ced4ddcb4097134ff3c332f" ma:index="16" nillable="true" ma:taxonomy="true" ma:internalName="lcf76f155ced4ddcb4097134ff3c332f" ma:taxonomyFieldName="MediaServiceImageTags" ma:displayName="Afbeeldingtags" ma:readOnly="false" ma:fieldId="{5cf76f15-5ced-4ddc-b409-7134ff3c332f}" ma:taxonomyMulti="true" ma:sspId="d8abf3bf-0b1b-4cb8-a5ae-80d4e8bc7d28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BillingMetadata" ma:index="17" nillable="true" ma:displayName="MediaServiceBillingMetadata" ma:hidden="true" ma:internalName="MediaServiceBillingMetadata" ma:readOnly="true">
      <xsd:simpleType>
        <xsd:restriction base="dms:Note"/>
      </xsd:simpleType>
    </xsd:element>
    <xsd:element name="MediaServiceOCR" ma:index="18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Location" ma:index="19" nillable="true" ma:displayName="Location" ma:description="" ma:indexed="true" ma:internalName="MediaServiceLocation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Inhoudstype"/>
        <xsd:element ref="dc:title" minOccurs="0" maxOccurs="1" ma:index="4" ma:displayName="Titel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76D3B9F2-21F2-4712-AA9E-0ABCFEA1E22A}">
  <ds:schemaRefs>
    <ds:schemaRef ds:uri="http://purl.org/dc/elements/1.1/"/>
    <ds:schemaRef ds:uri="http://schemas.microsoft.com/office/2006/documentManagement/types"/>
    <ds:schemaRef ds:uri="http://schemas.microsoft.com/office/2006/metadata/properties"/>
    <ds:schemaRef ds:uri="http://schemas.microsoft.com/office/infopath/2007/PartnerControls"/>
    <ds:schemaRef ds:uri="http://purl.org/dc/dcmitype/"/>
    <ds:schemaRef ds:uri="7d494ce6-7da9-4269-988c-cd0648e54523"/>
    <ds:schemaRef ds:uri="http://schemas.openxmlformats.org/package/2006/metadata/core-properties"/>
    <ds:schemaRef ds:uri="http://www.w3.org/XML/1998/namespace"/>
    <ds:schemaRef ds:uri="http://purl.org/dc/terms/"/>
  </ds:schemaRefs>
</ds:datastoreItem>
</file>

<file path=customXml/itemProps2.xml><?xml version="1.0" encoding="utf-8"?>
<ds:datastoreItem xmlns:ds="http://schemas.openxmlformats.org/officeDocument/2006/customXml" ds:itemID="{D84936DA-089D-4062-A271-58DED03E5AF4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8FEF1C93-1A99-410B-BFC7-B47E34E1EBBA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7d494ce6-7da9-4269-988c-cd0648e54523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021</TotalTime>
  <Words>152</Words>
  <Application>Microsoft Office PowerPoint</Application>
  <PresentationFormat>Breedbeeld</PresentationFormat>
  <Paragraphs>25</Paragraphs>
  <Slides>1</Slides>
  <Notes>1</Notes>
  <HiddenSlides>0</HiddenSlides>
  <MMClips>0</MMClips>
  <ScaleCrop>false</ScaleCrop>
  <HeadingPairs>
    <vt:vector size="6" baseType="variant">
      <vt:variant>
        <vt:lpstr>Gebruikte lettertypen</vt:lpstr>
      </vt:variant>
      <vt:variant>
        <vt:i4>3</vt:i4>
      </vt:variant>
      <vt:variant>
        <vt:lpstr>Thema</vt:lpstr>
      </vt:variant>
      <vt:variant>
        <vt:i4>1</vt:i4>
      </vt:variant>
      <vt:variant>
        <vt:lpstr>Diatitel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i Office</vt:lpstr>
      <vt:lpstr>PowerPoint-presentatie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M.mazzarella</dc:creator>
  <cp:lastModifiedBy>Harker, Mitchell</cp:lastModifiedBy>
  <cp:revision>98</cp:revision>
  <dcterms:created xsi:type="dcterms:W3CDTF">2017-10-03T08:27:08Z</dcterms:created>
  <dcterms:modified xsi:type="dcterms:W3CDTF">2026-01-09T14:17:1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1C9D8233362EC04098325F441C5BC7E7</vt:lpwstr>
  </property>
  <property fmtid="{D5CDD505-2E9C-101B-9397-08002B2CF9AE}" pid="3" name="MediaServiceImageTags">
    <vt:lpwstr/>
  </property>
</Properties>
</file>